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7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83209C-1C5F-49E7-BB99-CC7AFEDEAD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C4CAC4A-9A1B-44DF-97E1-01A82E1B6C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A27FCFE-7C69-4DF5-8BAB-3C974A12E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26C96DF-0043-444A-A48D-61D4DE6EA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B9BD8A7-22B3-4F26-B9AB-83340DB37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400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6AA62B-31BD-4788-A263-A4CE22CF8E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422FE9EF-8969-46DA-BFD8-72DAA089AC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4873B29-AE11-4877-96ED-1F9EA2EAB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157B0C7-9715-4AEA-BC72-DBC9B2BE8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C081796-D0E0-49CB-B049-09C7D8F91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90953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A3AE8CD-501E-4FA1-B72B-4A160658E6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90C28CB-2FFF-44A8-8473-FC44EA194F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A8BF207-250C-4679-830C-5B984036F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C934225-0ECC-4ACF-86DE-9BD354649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2C14801-D38B-456B-B674-6504EB81E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97953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79D88B-BBA5-49D4-81F8-7067393D52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ECC785D-2F8A-4D88-8CD9-53713F0931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937AD53-2BED-4029-BD07-225B6403F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EE53420-B853-489D-81F0-2FCE3823D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DE15D9E-725A-4A74-A1AD-1AF5C1D82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02586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5C70D4-6430-4471-A391-F00C096FB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0342CC7-1325-4C47-8C67-E8394A8BC0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BC962F7-C04B-458C-8E7B-E6F7F07CC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84CE475-E250-4E01-9DAD-2DDCE2267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96091C0-66C8-4BC2-8CE1-E3307801B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628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7A5B835-39A2-4F7C-8E06-8D2861D44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BEE1427-B088-4540-B9F4-2D1A0E3504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E8A82660-CF2A-4C60-9CA8-DD191FEFA7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09D6283D-DA02-43D5-B2A6-476FE1F8A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45F5CE3-C740-46C2-B804-9CA9B89BE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7C2830BF-CBE8-44D0-8FFB-20D8549BB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70916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EB623B-B2B0-401E-8717-DF70CDA20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430727E3-CE89-45F9-832A-4DEA256003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C1CA85AB-4FFD-46F0-BD79-C49B708338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23583C15-ECC6-4AEA-80D8-B7E013BDFB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43EC1ACE-B04E-4706-8DDB-10F8C50214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E53182D8-2C3F-47F3-B5CF-3C4D61F5D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80E5C96C-CFC7-4A9E-80C4-7B60B35CC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5BA5DEE0-B776-438A-BFD8-108986E00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95408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7D97635-1007-4169-AA20-D4E6FDB4E5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E741C9DC-9747-43D9-ABEB-A7FACC87C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AEC542F3-1A6C-49A2-93D8-5540B7FF2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B2A6E589-B842-4581-A1B5-DF8DF56D2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74911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56439C4E-6D60-420E-9EAF-BD28EC276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6B4F21DE-A5F2-4733-AEA7-E66E4CE26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72C11F48-7144-4EA0-B436-7A7D949F1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41725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F571B9-D18C-4F27-8E1C-819F97B02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7C7DD72-68E6-4995-9F84-D1660518CB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8FD07863-0D2C-424E-B271-980C5DEACB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2551E9C-38E7-43D6-B9E8-14A4DE68D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F4556034-5E8C-4178-94B1-AF8373FDE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49B746CC-9FD3-4712-9067-D3283BAD6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62930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91BE29-FFE0-484A-9678-525073B6A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5E70A0C4-EF93-4025-9142-C15757DA78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C7588ABD-0035-4EFA-B82C-306B864B12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2F6F6CB-2C3A-4C94-94B6-82699D1DB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148B1A14-B5BE-4066-8517-B7195655A1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16053D3-DF86-495D-9D47-D07CEB502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2781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92F86334-116E-408A-8A3A-06AF3FB04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3737D4B1-B67A-4D7D-8079-16711D0636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8AEA304-317C-469F-BD58-CA158C0DDA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9B1F5-628A-4A65-A576-B3D2E0CBFFC9}" type="datetimeFigureOut">
              <a:rPr lang="pt-BR" smtClean="0"/>
              <a:t>11/05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8FD45D3-9EAE-4F05-8312-D8E3D8AD42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C5B6EEF-99A7-498C-8A7A-5A78EE657E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8A79F6-7CD5-42CA-AD51-2716AB68DE5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19054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1055661" y="6002345"/>
            <a:ext cx="95025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S1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nity stress assay. Representative non-transgenic (N) and RD29a:DREB1a (T) seedlings exposed to  0, 100 or 150 mM of NaCl for 12 (a-b) or 15 (c-d) days. Note the seedling length in (a-b) and leaf necrosis (arrows) in (c-d) under salt stress .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1274695" y="303234"/>
            <a:ext cx="8699197" cy="5603842"/>
            <a:chOff x="1227193" y="77602"/>
            <a:chExt cx="8699197" cy="560384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DDA9BAD-3620-25CC-A678-E006F51BB1C1}"/>
                </a:ext>
              </a:extLst>
            </p:cNvPr>
            <p:cNvGrpSpPr/>
            <p:nvPr/>
          </p:nvGrpSpPr>
          <p:grpSpPr>
            <a:xfrm>
              <a:off x="1227193" y="77602"/>
              <a:ext cx="8699197" cy="5603842"/>
              <a:chOff x="1227193" y="498226"/>
              <a:chExt cx="8699197" cy="5603842"/>
            </a:xfrm>
          </p:grpSpPr>
          <p:pic>
            <p:nvPicPr>
              <p:cNvPr id="5" name="Imagem 4" descr="Garrafa de plástico&#10;&#10;Descrição gerada automaticamente com confiança média">
                <a:extLst>
                  <a:ext uri="{FF2B5EF4-FFF2-40B4-BE49-F238E27FC236}">
                    <a16:creationId xmlns:a16="http://schemas.microsoft.com/office/drawing/2014/main" id="{297DF8E0-CBF1-4C91-9737-E80657AAEA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59422" y="739329"/>
                <a:ext cx="4166968" cy="2827107"/>
              </a:xfrm>
              <a:prstGeom prst="rect">
                <a:avLst/>
              </a:prstGeom>
            </p:spPr>
          </p:pic>
          <p:pic>
            <p:nvPicPr>
              <p:cNvPr id="7" name="Imagem 6" descr="Uma imagem contendo mesa, no interior, garrafa, vinho&#10;&#10;Descrição gerada automaticamente">
                <a:extLst>
                  <a:ext uri="{FF2B5EF4-FFF2-40B4-BE49-F238E27FC236}">
                    <a16:creationId xmlns:a16="http://schemas.microsoft.com/office/drawing/2014/main" id="{D88D7921-BA2F-4B90-919C-406C1B8ACD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189"/>
              <a:stretch/>
            </p:blipFill>
            <p:spPr>
              <a:xfrm>
                <a:off x="1527135" y="739330"/>
                <a:ext cx="3977192" cy="2827107"/>
              </a:xfrm>
              <a:prstGeom prst="rect">
                <a:avLst/>
              </a:prstGeom>
            </p:spPr>
          </p:pic>
          <p:sp>
            <p:nvSpPr>
              <p:cNvPr id="8" name="CaixaDeTexto 7">
                <a:extLst>
                  <a:ext uri="{FF2B5EF4-FFF2-40B4-BE49-F238E27FC236}">
                    <a16:creationId xmlns:a16="http://schemas.microsoft.com/office/drawing/2014/main" id="{B696FC90-00B7-4851-B072-E8D6CFF1096D}"/>
                  </a:ext>
                </a:extLst>
              </p:cNvPr>
              <p:cNvSpPr txBox="1"/>
              <p:nvPr/>
            </p:nvSpPr>
            <p:spPr>
              <a:xfrm>
                <a:off x="1549795" y="739329"/>
                <a:ext cx="55181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200" b="1" dirty="0">
                    <a:solidFill>
                      <a:schemeClr val="bg1"/>
                    </a:solidFill>
                  </a:rPr>
                  <a:t>(a)</a:t>
                </a:r>
              </a:p>
            </p:txBody>
          </p:sp>
          <p:sp>
            <p:nvSpPr>
              <p:cNvPr id="9" name="CaixaDeTexto 8">
                <a:extLst>
                  <a:ext uri="{FF2B5EF4-FFF2-40B4-BE49-F238E27FC236}">
                    <a16:creationId xmlns:a16="http://schemas.microsoft.com/office/drawing/2014/main" id="{4C9C2CFE-7C0A-4D58-9478-535097CE5E02}"/>
                  </a:ext>
                </a:extLst>
              </p:cNvPr>
              <p:cNvSpPr txBox="1"/>
              <p:nvPr/>
            </p:nvSpPr>
            <p:spPr>
              <a:xfrm>
                <a:off x="5911289" y="749876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200" b="1" dirty="0">
                    <a:solidFill>
                      <a:schemeClr val="bg1"/>
                    </a:solidFill>
                  </a:rPr>
                  <a:t>(b)</a:t>
                </a:r>
              </a:p>
            </p:txBody>
          </p:sp>
          <p:pic>
            <p:nvPicPr>
              <p:cNvPr id="11" name="Imagem 2" descr="Lousa com texto preto sobre fundo branco&#10;&#10;Descrição gerada automaticamente com confiança baixa">
                <a:extLst>
                  <a:ext uri="{FF2B5EF4-FFF2-40B4-BE49-F238E27FC236}">
                    <a16:creationId xmlns:a16="http://schemas.microsoft.com/office/drawing/2014/main" id="{43D7011B-5627-47CC-925D-74361475D0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46" r="-140"/>
              <a:stretch/>
            </p:blipFill>
            <p:spPr>
              <a:xfrm>
                <a:off x="1577787" y="3660735"/>
                <a:ext cx="3980330" cy="2211496"/>
              </a:xfrm>
              <a:prstGeom prst="rect">
                <a:avLst/>
              </a:prstGeom>
            </p:spPr>
          </p:pic>
          <p:pic>
            <p:nvPicPr>
              <p:cNvPr id="12" name="Imagem 4" descr="Tela de computador com texto preto sobre fundo branco&#10;&#10;Descrição gerada automaticamente com confiança média">
                <a:extLst>
                  <a:ext uri="{FF2B5EF4-FFF2-40B4-BE49-F238E27FC236}">
                    <a16:creationId xmlns:a16="http://schemas.microsoft.com/office/drawing/2014/main" id="{FF3D2A3B-451E-4EF9-BB2C-D73531004D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59422" y="3639394"/>
                <a:ext cx="4166968" cy="2212447"/>
              </a:xfrm>
              <a:prstGeom prst="rect">
                <a:avLst/>
              </a:prstGeom>
            </p:spPr>
          </p:pic>
          <p:sp>
            <p:nvSpPr>
              <p:cNvPr id="13" name="CaixaDeTexto 6">
                <a:extLst>
                  <a:ext uri="{FF2B5EF4-FFF2-40B4-BE49-F238E27FC236}">
                    <a16:creationId xmlns:a16="http://schemas.microsoft.com/office/drawing/2014/main" id="{1EA55A52-57E8-48A0-9FD9-4F80B9941311}"/>
                  </a:ext>
                </a:extLst>
              </p:cNvPr>
              <p:cNvSpPr txBox="1"/>
              <p:nvPr/>
            </p:nvSpPr>
            <p:spPr>
              <a:xfrm>
                <a:off x="1549795" y="3639394"/>
                <a:ext cx="4878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200" b="1" dirty="0">
                    <a:solidFill>
                      <a:schemeClr val="bg1"/>
                    </a:solidFill>
                  </a:rPr>
                  <a:t>(c)</a:t>
                </a:r>
              </a:p>
            </p:txBody>
          </p:sp>
          <p:sp>
            <p:nvSpPr>
              <p:cNvPr id="14" name="CaixaDeTexto 7">
                <a:extLst>
                  <a:ext uri="{FF2B5EF4-FFF2-40B4-BE49-F238E27FC236}">
                    <a16:creationId xmlns:a16="http://schemas.microsoft.com/office/drawing/2014/main" id="{D6C978AD-857D-46C3-804A-EF9E727C1CD1}"/>
                  </a:ext>
                </a:extLst>
              </p:cNvPr>
              <p:cNvSpPr txBox="1"/>
              <p:nvPr/>
            </p:nvSpPr>
            <p:spPr>
              <a:xfrm>
                <a:off x="5759422" y="3614003"/>
                <a:ext cx="6006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200" b="1" dirty="0">
                    <a:solidFill>
                      <a:schemeClr val="bg1"/>
                    </a:solidFill>
                  </a:rPr>
                  <a:t>(d)</a:t>
                </a:r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>
                <a:off x="1825703" y="5825069"/>
                <a:ext cx="5533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0 </a:t>
                </a:r>
                <a:r>
                  <a:rPr lang="en-US" sz="1200" b="1" dirty="0" err="1"/>
                  <a:t>mM</a:t>
                </a:r>
                <a:endParaRPr lang="en-US" sz="1200" b="1" dirty="0"/>
              </a:p>
            </p:txBody>
          </p:sp>
          <p:cxnSp>
            <p:nvCxnSpPr>
              <p:cNvPr id="4" name="Straight Connector 3"/>
              <p:cNvCxnSpPr/>
              <p:nvPr/>
            </p:nvCxnSpPr>
            <p:spPr>
              <a:xfrm>
                <a:off x="2841811" y="739328"/>
                <a:ext cx="26894" cy="524233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3943051" y="691105"/>
                <a:ext cx="26894" cy="524233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3037828" y="5825069"/>
                <a:ext cx="7104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00 </a:t>
                </a:r>
                <a:r>
                  <a:rPr lang="en-US" sz="1200" b="1" dirty="0" err="1"/>
                  <a:t>mM</a:t>
                </a:r>
                <a:endParaRPr lang="en-US" sz="12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337471" y="5825069"/>
                <a:ext cx="7104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50 </a:t>
                </a:r>
                <a:r>
                  <a:rPr lang="en-US" sz="1200" b="1" dirty="0" err="1"/>
                  <a:t>mM</a:t>
                </a:r>
                <a:endParaRPr lang="en-US" sz="12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034143" y="5825069"/>
                <a:ext cx="5533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0 </a:t>
                </a:r>
                <a:r>
                  <a:rPr lang="en-US" sz="1200" b="1" dirty="0" err="1"/>
                  <a:t>mM</a:t>
                </a:r>
                <a:endParaRPr lang="en-US" sz="12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246268" y="5825069"/>
                <a:ext cx="7104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00 </a:t>
                </a:r>
                <a:r>
                  <a:rPr lang="en-US" sz="1200" b="1" dirty="0" err="1"/>
                  <a:t>mM</a:t>
                </a:r>
                <a:endParaRPr lang="en-US" sz="12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8545911" y="5825069"/>
                <a:ext cx="7104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50 </a:t>
                </a:r>
                <a:r>
                  <a:rPr lang="en-US" sz="1200" b="1" dirty="0" err="1"/>
                  <a:t>mM</a:t>
                </a:r>
                <a:endParaRPr lang="en-US" sz="1200" b="1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698119" y="506035"/>
                <a:ext cx="13898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Non-transgenic (N)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716755" y="498226"/>
                <a:ext cx="20969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 RD29a:DREB1a Transgenic (T)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522224" y="2014382"/>
                <a:ext cx="16869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2 days after treatment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522224" y="4514831"/>
                <a:ext cx="16869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5 days after treatment</a:t>
                </a:r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E491C5E6-F85D-A35F-1486-B19075F89E8F}"/>
                  </a:ext>
                </a:extLst>
              </p:cNvPr>
              <p:cNvCxnSpPr/>
              <p:nvPr/>
            </p:nvCxnSpPr>
            <p:spPr>
              <a:xfrm>
                <a:off x="7095495" y="670489"/>
                <a:ext cx="26894" cy="524233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D1105244-B852-F23B-74F2-EF9C44474A04}"/>
                  </a:ext>
                </a:extLst>
              </p:cNvPr>
              <p:cNvCxnSpPr/>
              <p:nvPr/>
            </p:nvCxnSpPr>
            <p:spPr>
              <a:xfrm>
                <a:off x="8196735" y="622266"/>
                <a:ext cx="26894" cy="524233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33314DE8-D9DF-59D0-9087-8B52D4E17F57}"/>
                </a:ext>
              </a:extLst>
            </p:cNvPr>
            <p:cNvCxnSpPr/>
            <p:nvPr/>
          </p:nvCxnSpPr>
          <p:spPr>
            <a:xfrm flipH="1">
              <a:off x="3300984" y="3941064"/>
              <a:ext cx="118872" cy="1920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E0DB22DA-10AD-C684-1230-60E6BD8BAB91}"/>
                </a:ext>
              </a:extLst>
            </p:cNvPr>
            <p:cNvCxnSpPr/>
            <p:nvPr/>
          </p:nvCxnSpPr>
          <p:spPr>
            <a:xfrm flipH="1">
              <a:off x="3508516" y="4037076"/>
              <a:ext cx="118872" cy="1920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B718C6C4-FDB0-CC0F-B1EB-0A8A61E8FE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48268" y="4162044"/>
              <a:ext cx="118872" cy="1920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90367077-D9EA-301B-22F8-4729ADAA668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47300" y="4218601"/>
              <a:ext cx="250" cy="12632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8A5361A1-D97E-F925-915A-F39C5FC4EF81}"/>
                </a:ext>
              </a:extLst>
            </p:cNvPr>
            <p:cNvCxnSpPr/>
            <p:nvPr/>
          </p:nvCxnSpPr>
          <p:spPr>
            <a:xfrm flipH="1">
              <a:off x="4874020" y="4012692"/>
              <a:ext cx="118872" cy="1920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42DA60FF-E2E8-95AA-1545-53D04685F1F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51516" y="4204716"/>
              <a:ext cx="27682" cy="15240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1D3CB2BF-9011-1E29-BC11-1E12E6F6952D}"/>
                </a:ext>
              </a:extLst>
            </p:cNvPr>
            <p:cNvCxnSpPr/>
            <p:nvPr/>
          </p:nvCxnSpPr>
          <p:spPr>
            <a:xfrm flipH="1">
              <a:off x="8546860" y="4283964"/>
              <a:ext cx="118872" cy="1920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712942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109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Yasmin Berchembrock</dc:creator>
  <cp:lastModifiedBy>Vibha Srivastava</cp:lastModifiedBy>
  <cp:revision>12</cp:revision>
  <dcterms:created xsi:type="dcterms:W3CDTF">2022-04-15T12:31:12Z</dcterms:created>
  <dcterms:modified xsi:type="dcterms:W3CDTF">2022-05-12T00:10:22Z</dcterms:modified>
</cp:coreProperties>
</file>